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2" d="100"/>
          <a:sy n="72" d="100"/>
        </p:scale>
        <p:origin x="-1312" y="-5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6F44B2-4E97-4B74-8DDA-DD09D5779D51}" type="datetimeFigureOut">
              <a:rPr lang="en-GB" smtClean="0"/>
              <a:t>23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8A06A-9CA1-4AE5-A745-BCF8779A83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40518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6F44B2-4E97-4B74-8DDA-DD09D5779D51}" type="datetimeFigureOut">
              <a:rPr lang="en-GB" smtClean="0"/>
              <a:t>23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8A06A-9CA1-4AE5-A745-BCF8779A83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04743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6F44B2-4E97-4B74-8DDA-DD09D5779D51}" type="datetimeFigureOut">
              <a:rPr lang="en-GB" smtClean="0"/>
              <a:t>23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8A06A-9CA1-4AE5-A745-BCF8779A83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807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6F44B2-4E97-4B74-8DDA-DD09D5779D51}" type="datetimeFigureOut">
              <a:rPr lang="en-GB" smtClean="0"/>
              <a:t>23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8A06A-9CA1-4AE5-A745-BCF8779A83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42643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6F44B2-4E97-4B74-8DDA-DD09D5779D51}" type="datetimeFigureOut">
              <a:rPr lang="en-GB" smtClean="0"/>
              <a:t>23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8A06A-9CA1-4AE5-A745-BCF8779A83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51695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6F44B2-4E97-4B74-8DDA-DD09D5779D51}" type="datetimeFigureOut">
              <a:rPr lang="en-GB" smtClean="0"/>
              <a:t>23/06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8A06A-9CA1-4AE5-A745-BCF8779A83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11282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6F44B2-4E97-4B74-8DDA-DD09D5779D51}" type="datetimeFigureOut">
              <a:rPr lang="en-GB" smtClean="0"/>
              <a:t>23/06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8A06A-9CA1-4AE5-A745-BCF8779A83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50933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6F44B2-4E97-4B74-8DDA-DD09D5779D51}" type="datetimeFigureOut">
              <a:rPr lang="en-GB" smtClean="0"/>
              <a:t>23/06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8A06A-9CA1-4AE5-A745-BCF8779A83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5715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6F44B2-4E97-4B74-8DDA-DD09D5779D51}" type="datetimeFigureOut">
              <a:rPr lang="en-GB" smtClean="0"/>
              <a:t>23/06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8A06A-9CA1-4AE5-A745-BCF8779A83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2507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6F44B2-4E97-4B74-8DDA-DD09D5779D51}" type="datetimeFigureOut">
              <a:rPr lang="en-GB" smtClean="0"/>
              <a:t>23/06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8A06A-9CA1-4AE5-A745-BCF8779A83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80392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6F44B2-4E97-4B74-8DDA-DD09D5779D51}" type="datetimeFigureOut">
              <a:rPr lang="en-GB" smtClean="0"/>
              <a:t>23/06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8A06A-9CA1-4AE5-A745-BCF8779A83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10220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6F44B2-4E97-4B74-8DDA-DD09D5779D51}" type="datetimeFigureOut">
              <a:rPr lang="en-GB" smtClean="0"/>
              <a:t>23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18A06A-9CA1-4AE5-A745-BCF8779A83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05278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wmeng\Downloads\Desktop\GWAS SDR\IOVS\Fig S2 QQPLOT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9672" y="188640"/>
            <a:ext cx="5495925" cy="53911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2427218" y="5633056"/>
            <a:ext cx="38884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Expected significance log10(1/</a:t>
            </a:r>
            <a:r>
              <a:rPr lang="en-GB" i="1" dirty="0" smtClean="0"/>
              <a:t>P</a:t>
            </a:r>
            <a:r>
              <a:rPr lang="en-GB" dirty="0" smtClean="0"/>
              <a:t>)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 rot="16200000">
            <a:off x="-643934" y="2380238"/>
            <a:ext cx="38884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Observed significance log10(1/</a:t>
            </a:r>
            <a:r>
              <a:rPr lang="en-GB" i="1" dirty="0" smtClean="0"/>
              <a:t>P</a:t>
            </a:r>
            <a:r>
              <a:rPr lang="en-GB" dirty="0" smtClean="0"/>
              <a:t>)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861864" y="5957082"/>
            <a:ext cx="744818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smtClean="0"/>
              <a:t>Fig</a:t>
            </a:r>
            <a:r>
              <a:rPr lang="en-US" altLang="zh-CN" b="1" dirty="0" smtClean="0"/>
              <a:t>.</a:t>
            </a:r>
            <a:r>
              <a:rPr lang="en-GB" b="1" dirty="0" smtClean="0"/>
              <a:t> </a:t>
            </a:r>
            <a:r>
              <a:rPr lang="en-US" altLang="zh-CN" b="1" dirty="0" smtClean="0"/>
              <a:t>S1</a:t>
            </a:r>
            <a:r>
              <a:rPr lang="en-GB" b="1" dirty="0" smtClean="0"/>
              <a:t> </a:t>
            </a:r>
            <a:r>
              <a:rPr lang="en-GB" dirty="0" smtClean="0"/>
              <a:t>Q-Q plot expected and observed log10(1/</a:t>
            </a:r>
            <a:r>
              <a:rPr lang="en-GB" i="1" dirty="0" smtClean="0"/>
              <a:t>P</a:t>
            </a:r>
            <a:r>
              <a:rPr lang="en-GB" dirty="0" smtClean="0"/>
              <a:t>) values</a:t>
            </a:r>
          </a:p>
          <a:p>
            <a:r>
              <a:rPr lang="en-GB" dirty="0" smtClean="0"/>
              <a:t>Only SNPs with </a:t>
            </a:r>
            <a:r>
              <a:rPr lang="en-GB" i="1" dirty="0" smtClean="0"/>
              <a:t>P</a:t>
            </a:r>
            <a:r>
              <a:rPr lang="en-GB" dirty="0" smtClean="0"/>
              <a:t> values &lt; 0.01 were used and their </a:t>
            </a:r>
            <a:r>
              <a:rPr lang="en-GB" i="1" dirty="0" smtClean="0"/>
              <a:t>P</a:t>
            </a:r>
            <a:r>
              <a:rPr lang="en-GB" dirty="0" smtClean="0"/>
              <a:t> values were multiplied 100 before plotting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8191811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8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ihua Meng</dc:creator>
  <cp:lastModifiedBy>Weihua Meng</cp:lastModifiedBy>
  <cp:revision>5</cp:revision>
  <dcterms:created xsi:type="dcterms:W3CDTF">2015-04-07T13:03:12Z</dcterms:created>
  <dcterms:modified xsi:type="dcterms:W3CDTF">2016-06-23T10:25:48Z</dcterms:modified>
</cp:coreProperties>
</file>